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7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85958788391642"/>
          <c:y val="4.1103358912352748E-2"/>
          <c:w val="0.83017363467816097"/>
          <c:h val="0.70749943582182739"/>
        </c:manualLayout>
      </c:layout>
      <c:lineChart>
        <c:grouping val="standard"/>
        <c:varyColors val="0"/>
        <c:ser>
          <c:idx val="0"/>
          <c:order val="0"/>
          <c:tx>
            <c:v>ARH77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J$6:$J$23</c:f>
                <c:numCache>
                  <c:formatCode>General</c:formatCode>
                  <c:ptCount val="18"/>
                  <c:pt idx="0">
                    <c:v>180638.6</c:v>
                  </c:pt>
                  <c:pt idx="1">
                    <c:v>236944.2</c:v>
                  </c:pt>
                  <c:pt idx="2">
                    <c:v>255740.5</c:v>
                  </c:pt>
                  <c:pt idx="3">
                    <c:v>272596.59999999998</c:v>
                  </c:pt>
                  <c:pt idx="4">
                    <c:v>285151.2</c:v>
                  </c:pt>
                  <c:pt idx="5">
                    <c:v>296416.7</c:v>
                  </c:pt>
                  <c:pt idx="6">
                    <c:v>295554.3</c:v>
                  </c:pt>
                  <c:pt idx="7">
                    <c:v>312676.3</c:v>
                  </c:pt>
                  <c:pt idx="8">
                    <c:v>343012.7</c:v>
                  </c:pt>
                  <c:pt idx="9">
                    <c:v>360681.9</c:v>
                  </c:pt>
                  <c:pt idx="10">
                    <c:v>354026.6</c:v>
                  </c:pt>
                  <c:pt idx="11">
                    <c:v>389570.6</c:v>
                  </c:pt>
                  <c:pt idx="12">
                    <c:v>372258.2</c:v>
                  </c:pt>
                  <c:pt idx="13">
                    <c:v>384224.1</c:v>
                  </c:pt>
                  <c:pt idx="14">
                    <c:v>383557.6</c:v>
                  </c:pt>
                  <c:pt idx="15">
                    <c:v>374207.1</c:v>
                  </c:pt>
                  <c:pt idx="16">
                    <c:v>340607.5</c:v>
                  </c:pt>
                  <c:pt idx="17">
                    <c:v>344325.9</c:v>
                  </c:pt>
                </c:numCache>
              </c:numRef>
            </c:plus>
            <c:minus>
              <c:numRef>
                <c:f>Sheet1!$J$6:$J$23</c:f>
                <c:numCache>
                  <c:formatCode>General</c:formatCode>
                  <c:ptCount val="18"/>
                  <c:pt idx="0">
                    <c:v>180638.6</c:v>
                  </c:pt>
                  <c:pt idx="1">
                    <c:v>236944.2</c:v>
                  </c:pt>
                  <c:pt idx="2">
                    <c:v>255740.5</c:v>
                  </c:pt>
                  <c:pt idx="3">
                    <c:v>272596.59999999998</c:v>
                  </c:pt>
                  <c:pt idx="4">
                    <c:v>285151.2</c:v>
                  </c:pt>
                  <c:pt idx="5">
                    <c:v>296416.7</c:v>
                  </c:pt>
                  <c:pt idx="6">
                    <c:v>295554.3</c:v>
                  </c:pt>
                  <c:pt idx="7">
                    <c:v>312676.3</c:v>
                  </c:pt>
                  <c:pt idx="8">
                    <c:v>343012.7</c:v>
                  </c:pt>
                  <c:pt idx="9">
                    <c:v>360681.9</c:v>
                  </c:pt>
                  <c:pt idx="10">
                    <c:v>354026.6</c:v>
                  </c:pt>
                  <c:pt idx="11">
                    <c:v>389570.6</c:v>
                  </c:pt>
                  <c:pt idx="12">
                    <c:v>372258.2</c:v>
                  </c:pt>
                  <c:pt idx="13">
                    <c:v>384224.1</c:v>
                  </c:pt>
                  <c:pt idx="14">
                    <c:v>383557.6</c:v>
                  </c:pt>
                  <c:pt idx="15">
                    <c:v>374207.1</c:v>
                  </c:pt>
                  <c:pt idx="16">
                    <c:v>340607.5</c:v>
                  </c:pt>
                  <c:pt idx="17">
                    <c:v>344325.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E$6:$E$23</c:f>
              <c:numCache>
                <c:formatCode>General</c:formatCode>
                <c:ptCount val="18"/>
                <c:pt idx="0">
                  <c:v>0</c:v>
                </c:pt>
                <c:pt idx="1">
                  <c:v>1</c:v>
                </c:pt>
                <c:pt idx="2">
                  <c:v>4</c:v>
                </c:pt>
                <c:pt idx="3">
                  <c:v>7</c:v>
                </c:pt>
                <c:pt idx="4">
                  <c:v>10</c:v>
                </c:pt>
                <c:pt idx="5">
                  <c:v>13</c:v>
                </c:pt>
                <c:pt idx="6">
                  <c:v>16</c:v>
                </c:pt>
                <c:pt idx="7">
                  <c:v>19</c:v>
                </c:pt>
                <c:pt idx="8">
                  <c:v>22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4</c:v>
                </c:pt>
                <c:pt idx="13">
                  <c:v>37</c:v>
                </c:pt>
                <c:pt idx="14">
                  <c:v>40</c:v>
                </c:pt>
                <c:pt idx="15">
                  <c:v>43</c:v>
                </c:pt>
                <c:pt idx="16">
                  <c:v>46</c:v>
                </c:pt>
                <c:pt idx="17">
                  <c:v>49</c:v>
                </c:pt>
              </c:numCache>
            </c:numRef>
          </c:cat>
          <c:val>
            <c:numRef>
              <c:f>Sheet1!$F$6:$F$23</c:f>
              <c:numCache>
                <c:formatCode>General</c:formatCode>
                <c:ptCount val="18"/>
                <c:pt idx="0">
                  <c:v>809868</c:v>
                </c:pt>
                <c:pt idx="1">
                  <c:v>840269.9</c:v>
                </c:pt>
                <c:pt idx="2">
                  <c:v>862982.3</c:v>
                </c:pt>
                <c:pt idx="3">
                  <c:v>918099.1</c:v>
                </c:pt>
                <c:pt idx="4">
                  <c:v>1011023</c:v>
                </c:pt>
                <c:pt idx="5">
                  <c:v>1059095</c:v>
                </c:pt>
                <c:pt idx="6">
                  <c:v>1086698</c:v>
                </c:pt>
                <c:pt idx="7">
                  <c:v>1138833</c:v>
                </c:pt>
                <c:pt idx="8">
                  <c:v>1215921</c:v>
                </c:pt>
                <c:pt idx="9">
                  <c:v>1269237</c:v>
                </c:pt>
                <c:pt idx="10">
                  <c:v>1321832</c:v>
                </c:pt>
                <c:pt idx="11">
                  <c:v>1412008</c:v>
                </c:pt>
                <c:pt idx="12">
                  <c:v>1448232</c:v>
                </c:pt>
                <c:pt idx="13">
                  <c:v>1465385</c:v>
                </c:pt>
                <c:pt idx="14">
                  <c:v>1497977</c:v>
                </c:pt>
                <c:pt idx="15">
                  <c:v>1545648</c:v>
                </c:pt>
                <c:pt idx="16">
                  <c:v>1554812</c:v>
                </c:pt>
                <c:pt idx="17">
                  <c:v>15957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FA0-4837-9755-04ECB95132ED}"/>
            </c:ext>
          </c:extLst>
        </c:ser>
        <c:ser>
          <c:idx val="1"/>
          <c:order val="1"/>
          <c:tx>
            <c:v>ARH77+Tubastatin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K$6:$K$23</c:f>
                <c:numCache>
                  <c:formatCode>General</c:formatCode>
                  <c:ptCount val="18"/>
                  <c:pt idx="0">
                    <c:v>93799.86</c:v>
                  </c:pt>
                  <c:pt idx="1">
                    <c:v>114449.8</c:v>
                  </c:pt>
                  <c:pt idx="2">
                    <c:v>102629.1</c:v>
                  </c:pt>
                  <c:pt idx="3">
                    <c:v>122253.4</c:v>
                  </c:pt>
                  <c:pt idx="4">
                    <c:v>115076.1</c:v>
                  </c:pt>
                  <c:pt idx="5">
                    <c:v>113626.2</c:v>
                  </c:pt>
                  <c:pt idx="6">
                    <c:v>124505.60000000001</c:v>
                  </c:pt>
                  <c:pt idx="7">
                    <c:v>138697.29999999999</c:v>
                  </c:pt>
                  <c:pt idx="8">
                    <c:v>142707.9</c:v>
                  </c:pt>
                  <c:pt idx="9">
                    <c:v>138160</c:v>
                  </c:pt>
                  <c:pt idx="10">
                    <c:v>137316.6</c:v>
                  </c:pt>
                  <c:pt idx="11">
                    <c:v>147869.9</c:v>
                  </c:pt>
                  <c:pt idx="12">
                    <c:v>130930</c:v>
                  </c:pt>
                  <c:pt idx="13">
                    <c:v>151390.1</c:v>
                  </c:pt>
                  <c:pt idx="14">
                    <c:v>113457.9</c:v>
                  </c:pt>
                  <c:pt idx="15">
                    <c:v>127293</c:v>
                  </c:pt>
                  <c:pt idx="16">
                    <c:v>113423.2</c:v>
                  </c:pt>
                  <c:pt idx="17">
                    <c:v>102935.5</c:v>
                  </c:pt>
                </c:numCache>
              </c:numRef>
            </c:plus>
            <c:minus>
              <c:numRef>
                <c:f>Sheet1!$K$6:$K$23</c:f>
                <c:numCache>
                  <c:formatCode>General</c:formatCode>
                  <c:ptCount val="18"/>
                  <c:pt idx="0">
                    <c:v>93799.86</c:v>
                  </c:pt>
                  <c:pt idx="1">
                    <c:v>114449.8</c:v>
                  </c:pt>
                  <c:pt idx="2">
                    <c:v>102629.1</c:v>
                  </c:pt>
                  <c:pt idx="3">
                    <c:v>122253.4</c:v>
                  </c:pt>
                  <c:pt idx="4">
                    <c:v>115076.1</c:v>
                  </c:pt>
                  <c:pt idx="5">
                    <c:v>113626.2</c:v>
                  </c:pt>
                  <c:pt idx="6">
                    <c:v>124505.60000000001</c:v>
                  </c:pt>
                  <c:pt idx="7">
                    <c:v>138697.29999999999</c:v>
                  </c:pt>
                  <c:pt idx="8">
                    <c:v>142707.9</c:v>
                  </c:pt>
                  <c:pt idx="9">
                    <c:v>138160</c:v>
                  </c:pt>
                  <c:pt idx="10">
                    <c:v>137316.6</c:v>
                  </c:pt>
                  <c:pt idx="11">
                    <c:v>147869.9</c:v>
                  </c:pt>
                  <c:pt idx="12">
                    <c:v>130930</c:v>
                  </c:pt>
                  <c:pt idx="13">
                    <c:v>151390.1</c:v>
                  </c:pt>
                  <c:pt idx="14">
                    <c:v>113457.9</c:v>
                  </c:pt>
                  <c:pt idx="15">
                    <c:v>127293</c:v>
                  </c:pt>
                  <c:pt idx="16">
                    <c:v>113423.2</c:v>
                  </c:pt>
                  <c:pt idx="17">
                    <c:v>102935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E$6:$E$23</c:f>
              <c:numCache>
                <c:formatCode>General</c:formatCode>
                <c:ptCount val="18"/>
                <c:pt idx="0">
                  <c:v>0</c:v>
                </c:pt>
                <c:pt idx="1">
                  <c:v>1</c:v>
                </c:pt>
                <c:pt idx="2">
                  <c:v>4</c:v>
                </c:pt>
                <c:pt idx="3">
                  <c:v>7</c:v>
                </c:pt>
                <c:pt idx="4">
                  <c:v>10</c:v>
                </c:pt>
                <c:pt idx="5">
                  <c:v>13</c:v>
                </c:pt>
                <c:pt idx="6">
                  <c:v>16</c:v>
                </c:pt>
                <c:pt idx="7">
                  <c:v>19</c:v>
                </c:pt>
                <c:pt idx="8">
                  <c:v>22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4</c:v>
                </c:pt>
                <c:pt idx="13">
                  <c:v>37</c:v>
                </c:pt>
                <c:pt idx="14">
                  <c:v>40</c:v>
                </c:pt>
                <c:pt idx="15">
                  <c:v>43</c:v>
                </c:pt>
                <c:pt idx="16">
                  <c:v>46</c:v>
                </c:pt>
                <c:pt idx="17">
                  <c:v>49</c:v>
                </c:pt>
              </c:numCache>
            </c:numRef>
          </c:cat>
          <c:val>
            <c:numRef>
              <c:f>Sheet1!$G$6:$G$23</c:f>
              <c:numCache>
                <c:formatCode>General</c:formatCode>
                <c:ptCount val="18"/>
                <c:pt idx="0">
                  <c:v>618689.4</c:v>
                </c:pt>
                <c:pt idx="1">
                  <c:v>592597.1</c:v>
                </c:pt>
                <c:pt idx="2">
                  <c:v>582007.9</c:v>
                </c:pt>
                <c:pt idx="3">
                  <c:v>569902.6</c:v>
                </c:pt>
                <c:pt idx="4">
                  <c:v>558024.80000000005</c:v>
                </c:pt>
                <c:pt idx="5">
                  <c:v>561863.69999999995</c:v>
                </c:pt>
                <c:pt idx="6">
                  <c:v>533721.30000000005</c:v>
                </c:pt>
                <c:pt idx="7">
                  <c:v>494460.5</c:v>
                </c:pt>
                <c:pt idx="8">
                  <c:v>466220.7</c:v>
                </c:pt>
                <c:pt idx="9">
                  <c:v>420294.6</c:v>
                </c:pt>
                <c:pt idx="10">
                  <c:v>394573.6</c:v>
                </c:pt>
                <c:pt idx="11">
                  <c:v>365518.3</c:v>
                </c:pt>
                <c:pt idx="12">
                  <c:v>320919</c:v>
                </c:pt>
                <c:pt idx="13">
                  <c:v>293741.8</c:v>
                </c:pt>
                <c:pt idx="14">
                  <c:v>279114.5</c:v>
                </c:pt>
                <c:pt idx="15">
                  <c:v>233448</c:v>
                </c:pt>
                <c:pt idx="16">
                  <c:v>195351.9</c:v>
                </c:pt>
                <c:pt idx="17">
                  <c:v>181604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FA0-4837-9755-04ECB95132ED}"/>
            </c:ext>
          </c:extLst>
        </c:ser>
        <c:ser>
          <c:idx val="2"/>
          <c:order val="2"/>
          <c:tx>
            <c:v>ARH77+ACY1215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M$6:$M$23</c:f>
                <c:numCache>
                  <c:formatCode>General</c:formatCode>
                  <c:ptCount val="18"/>
                  <c:pt idx="0">
                    <c:v>94298.79</c:v>
                  </c:pt>
                  <c:pt idx="1">
                    <c:v>118666.9</c:v>
                  </c:pt>
                  <c:pt idx="2">
                    <c:v>99720.49</c:v>
                  </c:pt>
                  <c:pt idx="3">
                    <c:v>84465.08</c:v>
                  </c:pt>
                  <c:pt idx="4">
                    <c:v>114355</c:v>
                  </c:pt>
                  <c:pt idx="5">
                    <c:v>138210.4</c:v>
                  </c:pt>
                  <c:pt idx="6">
                    <c:v>140347.9</c:v>
                  </c:pt>
                  <c:pt idx="7">
                    <c:v>243186.8</c:v>
                  </c:pt>
                  <c:pt idx="8">
                    <c:v>243446.3</c:v>
                  </c:pt>
                  <c:pt idx="9">
                    <c:v>226262.6</c:v>
                  </c:pt>
                  <c:pt idx="10">
                    <c:v>210794.5</c:v>
                  </c:pt>
                  <c:pt idx="11">
                    <c:v>193806</c:v>
                  </c:pt>
                  <c:pt idx="12">
                    <c:v>176885.6</c:v>
                  </c:pt>
                  <c:pt idx="13">
                    <c:v>162815.1</c:v>
                  </c:pt>
                  <c:pt idx="14">
                    <c:v>178506.7</c:v>
                  </c:pt>
                  <c:pt idx="15">
                    <c:v>194615.9</c:v>
                  </c:pt>
                  <c:pt idx="16">
                    <c:v>196062.1</c:v>
                  </c:pt>
                  <c:pt idx="17">
                    <c:v>178098.7</c:v>
                  </c:pt>
                </c:numCache>
              </c:numRef>
            </c:plus>
            <c:minus>
              <c:numRef>
                <c:f>Sheet1!$M$6:$M$23</c:f>
                <c:numCache>
                  <c:formatCode>General</c:formatCode>
                  <c:ptCount val="18"/>
                  <c:pt idx="0">
                    <c:v>94298.79</c:v>
                  </c:pt>
                  <c:pt idx="1">
                    <c:v>118666.9</c:v>
                  </c:pt>
                  <c:pt idx="2">
                    <c:v>99720.49</c:v>
                  </c:pt>
                  <c:pt idx="3">
                    <c:v>84465.08</c:v>
                  </c:pt>
                  <c:pt idx="4">
                    <c:v>114355</c:v>
                  </c:pt>
                  <c:pt idx="5">
                    <c:v>138210.4</c:v>
                  </c:pt>
                  <c:pt idx="6">
                    <c:v>140347.9</c:v>
                  </c:pt>
                  <c:pt idx="7">
                    <c:v>243186.8</c:v>
                  </c:pt>
                  <c:pt idx="8">
                    <c:v>243446.3</c:v>
                  </c:pt>
                  <c:pt idx="9">
                    <c:v>226262.6</c:v>
                  </c:pt>
                  <c:pt idx="10">
                    <c:v>210794.5</c:v>
                  </c:pt>
                  <c:pt idx="11">
                    <c:v>193806</c:v>
                  </c:pt>
                  <c:pt idx="12">
                    <c:v>176885.6</c:v>
                  </c:pt>
                  <c:pt idx="13">
                    <c:v>162815.1</c:v>
                  </c:pt>
                  <c:pt idx="14">
                    <c:v>178506.7</c:v>
                  </c:pt>
                  <c:pt idx="15">
                    <c:v>194615.9</c:v>
                  </c:pt>
                  <c:pt idx="16">
                    <c:v>196062.1</c:v>
                  </c:pt>
                  <c:pt idx="17">
                    <c:v>178098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E$6:$E$23</c:f>
              <c:numCache>
                <c:formatCode>General</c:formatCode>
                <c:ptCount val="18"/>
                <c:pt idx="0">
                  <c:v>0</c:v>
                </c:pt>
                <c:pt idx="1">
                  <c:v>1</c:v>
                </c:pt>
                <c:pt idx="2">
                  <c:v>4</c:v>
                </c:pt>
                <c:pt idx="3">
                  <c:v>7</c:v>
                </c:pt>
                <c:pt idx="4">
                  <c:v>10</c:v>
                </c:pt>
                <c:pt idx="5">
                  <c:v>13</c:v>
                </c:pt>
                <c:pt idx="6">
                  <c:v>16</c:v>
                </c:pt>
                <c:pt idx="7">
                  <c:v>19</c:v>
                </c:pt>
                <c:pt idx="8">
                  <c:v>22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4</c:v>
                </c:pt>
                <c:pt idx="13">
                  <c:v>37</c:v>
                </c:pt>
                <c:pt idx="14">
                  <c:v>40</c:v>
                </c:pt>
                <c:pt idx="15">
                  <c:v>43</c:v>
                </c:pt>
                <c:pt idx="16">
                  <c:v>46</c:v>
                </c:pt>
                <c:pt idx="17">
                  <c:v>49</c:v>
                </c:pt>
              </c:numCache>
            </c:numRef>
          </c:cat>
          <c:val>
            <c:numRef>
              <c:f>Sheet1!$I$6:$I$23</c:f>
              <c:numCache>
                <c:formatCode>General</c:formatCode>
                <c:ptCount val="18"/>
                <c:pt idx="0">
                  <c:v>663886.69999999995</c:v>
                </c:pt>
                <c:pt idx="1">
                  <c:v>608985.9</c:v>
                </c:pt>
                <c:pt idx="2">
                  <c:v>636875</c:v>
                </c:pt>
                <c:pt idx="3">
                  <c:v>632016.30000000005</c:v>
                </c:pt>
                <c:pt idx="4">
                  <c:v>587318.9</c:v>
                </c:pt>
                <c:pt idx="5">
                  <c:v>533274.6</c:v>
                </c:pt>
                <c:pt idx="6">
                  <c:v>512099.3</c:v>
                </c:pt>
                <c:pt idx="7">
                  <c:v>387480.3</c:v>
                </c:pt>
                <c:pt idx="8">
                  <c:v>372285.6</c:v>
                </c:pt>
                <c:pt idx="9">
                  <c:v>340145.5</c:v>
                </c:pt>
                <c:pt idx="10">
                  <c:v>310684.09999999998</c:v>
                </c:pt>
                <c:pt idx="11">
                  <c:v>287963.3</c:v>
                </c:pt>
                <c:pt idx="12">
                  <c:v>256867.20000000001</c:v>
                </c:pt>
                <c:pt idx="13">
                  <c:v>231430.5</c:v>
                </c:pt>
                <c:pt idx="14">
                  <c:v>229554.4</c:v>
                </c:pt>
                <c:pt idx="15">
                  <c:v>190567.4</c:v>
                </c:pt>
                <c:pt idx="16">
                  <c:v>181084.7</c:v>
                </c:pt>
                <c:pt idx="17">
                  <c:v>160248.2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FA0-4837-9755-04ECB95132ED}"/>
            </c:ext>
          </c:extLst>
        </c:ser>
        <c:ser>
          <c:idx val="3"/>
          <c:order val="3"/>
          <c:tx>
            <c:v>ARH77+ACY-738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L$6:$L$23</c:f>
                <c:numCache>
                  <c:formatCode>General</c:formatCode>
                  <c:ptCount val="18"/>
                  <c:pt idx="0">
                    <c:v>98248.41</c:v>
                  </c:pt>
                  <c:pt idx="1">
                    <c:v>54001.73</c:v>
                  </c:pt>
                  <c:pt idx="2">
                    <c:v>83375.240000000005</c:v>
                  </c:pt>
                  <c:pt idx="3">
                    <c:v>48389.41</c:v>
                  </c:pt>
                  <c:pt idx="4">
                    <c:v>77542.539999999994</c:v>
                  </c:pt>
                  <c:pt idx="5">
                    <c:v>53860.08</c:v>
                  </c:pt>
                  <c:pt idx="6">
                    <c:v>50188.23</c:v>
                  </c:pt>
                  <c:pt idx="7">
                    <c:v>82032.38</c:v>
                  </c:pt>
                  <c:pt idx="8">
                    <c:v>70215.31</c:v>
                  </c:pt>
                  <c:pt idx="9">
                    <c:v>61316.37</c:v>
                  </c:pt>
                  <c:pt idx="10">
                    <c:v>64267.37</c:v>
                  </c:pt>
                  <c:pt idx="11">
                    <c:v>69517.13</c:v>
                  </c:pt>
                  <c:pt idx="12">
                    <c:v>95325.2</c:v>
                  </c:pt>
                  <c:pt idx="13">
                    <c:v>94518.27</c:v>
                  </c:pt>
                  <c:pt idx="14">
                    <c:v>104366.3</c:v>
                  </c:pt>
                  <c:pt idx="15">
                    <c:v>91291.16</c:v>
                  </c:pt>
                  <c:pt idx="16">
                    <c:v>58198.17</c:v>
                  </c:pt>
                  <c:pt idx="17">
                    <c:v>44750.67</c:v>
                  </c:pt>
                </c:numCache>
              </c:numRef>
            </c:plus>
            <c:minus>
              <c:numRef>
                <c:f>Sheet1!$L$6:$L$23</c:f>
                <c:numCache>
                  <c:formatCode>General</c:formatCode>
                  <c:ptCount val="18"/>
                  <c:pt idx="0">
                    <c:v>98248.41</c:v>
                  </c:pt>
                  <c:pt idx="1">
                    <c:v>54001.73</c:v>
                  </c:pt>
                  <c:pt idx="2">
                    <c:v>83375.240000000005</c:v>
                  </c:pt>
                  <c:pt idx="3">
                    <c:v>48389.41</c:v>
                  </c:pt>
                  <c:pt idx="4">
                    <c:v>77542.539999999994</c:v>
                  </c:pt>
                  <c:pt idx="5">
                    <c:v>53860.08</c:v>
                  </c:pt>
                  <c:pt idx="6">
                    <c:v>50188.23</c:v>
                  </c:pt>
                  <c:pt idx="7">
                    <c:v>82032.38</c:v>
                  </c:pt>
                  <c:pt idx="8">
                    <c:v>70215.31</c:v>
                  </c:pt>
                  <c:pt idx="9">
                    <c:v>61316.37</c:v>
                  </c:pt>
                  <c:pt idx="10">
                    <c:v>64267.37</c:v>
                  </c:pt>
                  <c:pt idx="11">
                    <c:v>69517.13</c:v>
                  </c:pt>
                  <c:pt idx="12">
                    <c:v>95325.2</c:v>
                  </c:pt>
                  <c:pt idx="13">
                    <c:v>94518.27</c:v>
                  </c:pt>
                  <c:pt idx="14">
                    <c:v>104366.3</c:v>
                  </c:pt>
                  <c:pt idx="15">
                    <c:v>91291.16</c:v>
                  </c:pt>
                  <c:pt idx="16">
                    <c:v>58198.17</c:v>
                  </c:pt>
                  <c:pt idx="17">
                    <c:v>44750.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E$6:$E$23</c:f>
              <c:numCache>
                <c:formatCode>General</c:formatCode>
                <c:ptCount val="18"/>
                <c:pt idx="0">
                  <c:v>0</c:v>
                </c:pt>
                <c:pt idx="1">
                  <c:v>1</c:v>
                </c:pt>
                <c:pt idx="2">
                  <c:v>4</c:v>
                </c:pt>
                <c:pt idx="3">
                  <c:v>7</c:v>
                </c:pt>
                <c:pt idx="4">
                  <c:v>10</c:v>
                </c:pt>
                <c:pt idx="5">
                  <c:v>13</c:v>
                </c:pt>
                <c:pt idx="6">
                  <c:v>16</c:v>
                </c:pt>
                <c:pt idx="7">
                  <c:v>19</c:v>
                </c:pt>
                <c:pt idx="8">
                  <c:v>22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4</c:v>
                </c:pt>
                <c:pt idx="13">
                  <c:v>37</c:v>
                </c:pt>
                <c:pt idx="14">
                  <c:v>40</c:v>
                </c:pt>
                <c:pt idx="15">
                  <c:v>43</c:v>
                </c:pt>
                <c:pt idx="16">
                  <c:v>46</c:v>
                </c:pt>
                <c:pt idx="17">
                  <c:v>49</c:v>
                </c:pt>
              </c:numCache>
            </c:numRef>
          </c:cat>
          <c:val>
            <c:numRef>
              <c:f>Sheet1!$H$6:$H$23</c:f>
              <c:numCache>
                <c:formatCode>General</c:formatCode>
                <c:ptCount val="18"/>
                <c:pt idx="0">
                  <c:v>761154.6</c:v>
                </c:pt>
                <c:pt idx="1">
                  <c:v>702894.2</c:v>
                </c:pt>
                <c:pt idx="2">
                  <c:v>691677.2</c:v>
                </c:pt>
                <c:pt idx="3">
                  <c:v>696469.8</c:v>
                </c:pt>
                <c:pt idx="4">
                  <c:v>708979.1</c:v>
                </c:pt>
                <c:pt idx="5">
                  <c:v>662893.1</c:v>
                </c:pt>
                <c:pt idx="6">
                  <c:v>652229.6</c:v>
                </c:pt>
                <c:pt idx="7">
                  <c:v>644708.6</c:v>
                </c:pt>
                <c:pt idx="8">
                  <c:v>596310.1</c:v>
                </c:pt>
                <c:pt idx="9">
                  <c:v>502614.9</c:v>
                </c:pt>
                <c:pt idx="10">
                  <c:v>474569.6</c:v>
                </c:pt>
                <c:pt idx="11">
                  <c:v>440739</c:v>
                </c:pt>
                <c:pt idx="12">
                  <c:v>418005.8</c:v>
                </c:pt>
                <c:pt idx="13">
                  <c:v>379329.5</c:v>
                </c:pt>
                <c:pt idx="14">
                  <c:v>372271.7</c:v>
                </c:pt>
                <c:pt idx="15">
                  <c:v>317366.90000000002</c:v>
                </c:pt>
                <c:pt idx="16">
                  <c:v>270421</c:v>
                </c:pt>
                <c:pt idx="17">
                  <c:v>242136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FA0-4837-9755-04ECB95132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77937791"/>
        <c:axId val="1592931439"/>
      </c:lineChart>
      <c:catAx>
        <c:axId val="4779377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latin typeface="Arial" panose="020B0604020202020204" pitchFamily="34" charset="0"/>
                    <a:cs typeface="Arial" panose="020B0604020202020204" pitchFamily="34" charset="0"/>
                  </a:rPr>
                  <a:t>Time, hours</a:t>
                </a:r>
              </a:p>
            </c:rich>
          </c:tx>
          <c:layout>
            <c:manualLayout>
              <c:xMode val="edge"/>
              <c:yMode val="edge"/>
              <c:x val="0.43714511459112015"/>
              <c:y val="0.835154806656147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2931439"/>
        <c:crosses val="autoZero"/>
        <c:auto val="1"/>
        <c:lblAlgn val="ctr"/>
        <c:lblOffset val="100"/>
        <c:noMultiLvlLbl val="0"/>
      </c:catAx>
      <c:valAx>
        <c:axId val="1592931439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79377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"/>
          <c:y val="0.22408444256446333"/>
          <c:w val="0.83017363467816097"/>
          <c:h val="0.70749943582182739"/>
        </c:manualLayout>
      </c:layout>
      <c:lineChart>
        <c:grouping val="standar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77937791"/>
        <c:axId val="1592931439"/>
      </c:lineChart>
      <c:catAx>
        <c:axId val="477937791"/>
        <c:scaling>
          <c:orientation val="minMax"/>
        </c:scaling>
        <c:delete val="1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l"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MM cells</a:t>
                </a:r>
              </a:p>
              <a:p>
                <a:pPr algn="l">
                  <a:defRPr/>
                </a:pP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MM cells + Tubastatin</a:t>
                </a:r>
              </a:p>
              <a:p>
                <a:pPr algn="l">
                  <a:defRPr/>
                </a:pP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MM cells + ACY1215</a:t>
                </a:r>
              </a:p>
              <a:p>
                <a:pPr algn="l">
                  <a:defRPr/>
                </a:pP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MM cells + ACY738</a:t>
                </a:r>
              </a:p>
              <a:p>
                <a:pPr algn="l">
                  <a:defRPr/>
                </a:pPr>
                <a:endParaRPr lang="en-US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18935229957763081"/>
              <c:y val="0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l"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crossAx val="1592931439"/>
        <c:crosses val="autoZero"/>
        <c:auto val="1"/>
        <c:lblAlgn val="ctr"/>
        <c:lblOffset val="100"/>
        <c:noMultiLvlLbl val="0"/>
      </c:catAx>
      <c:valAx>
        <c:axId val="1592931439"/>
        <c:scaling>
          <c:orientation val="minMax"/>
          <c:min val="0"/>
        </c:scaling>
        <c:delete val="1"/>
        <c:axPos val="l"/>
        <c:numFmt formatCode="General" sourceLinked="1"/>
        <c:majorTickMark val="none"/>
        <c:minorTickMark val="none"/>
        <c:tickLblPos val="nextTo"/>
        <c:crossAx val="477937791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C8D9895D-F82A-EC43-97F7-7EC07D77F178}"/>
              </a:ext>
            </a:extLst>
          </p:cNvPr>
          <p:cNvSpPr txBox="1"/>
          <p:nvPr/>
        </p:nvSpPr>
        <p:spPr>
          <a:xfrm>
            <a:off x="2688801" y="785096"/>
            <a:ext cx="6030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t = 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9B26090-C4AB-AE36-F33A-81EF497F9AF0}"/>
              </a:ext>
            </a:extLst>
          </p:cNvPr>
          <p:cNvSpPr txBox="1"/>
          <p:nvPr/>
        </p:nvSpPr>
        <p:spPr>
          <a:xfrm>
            <a:off x="3663505" y="785096"/>
            <a:ext cx="1343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t = 48 hour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7663425-B56A-2A24-5D87-C766B909EBCE}"/>
              </a:ext>
            </a:extLst>
          </p:cNvPr>
          <p:cNvSpPr txBox="1"/>
          <p:nvPr/>
        </p:nvSpPr>
        <p:spPr>
          <a:xfrm rot="16200000">
            <a:off x="1901129" y="1318300"/>
            <a:ext cx="585417" cy="284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50" b="1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endParaRPr lang="en-US" sz="12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4DD1656-E31C-4037-DFDE-E69A7195E43E}"/>
              </a:ext>
            </a:extLst>
          </p:cNvPr>
          <p:cNvSpPr txBox="1"/>
          <p:nvPr/>
        </p:nvSpPr>
        <p:spPr>
          <a:xfrm rot="16200000">
            <a:off x="1617749" y="2355044"/>
            <a:ext cx="1152175" cy="284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50" b="1">
                <a:latin typeface="Arial" panose="020B0604020202020204" pitchFamily="34" charset="0"/>
                <a:cs typeface="Arial" panose="020B0604020202020204" pitchFamily="34" charset="0"/>
              </a:rPr>
              <a:t>Tubastatin-A</a:t>
            </a:r>
            <a:endParaRPr lang="en-US" sz="12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8908B85-ABED-3264-7456-AAE1E3515427}"/>
              </a:ext>
            </a:extLst>
          </p:cNvPr>
          <p:cNvSpPr txBox="1"/>
          <p:nvPr/>
        </p:nvSpPr>
        <p:spPr>
          <a:xfrm rot="16200000">
            <a:off x="1775708" y="4364382"/>
            <a:ext cx="836255" cy="284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50" b="1" dirty="0">
                <a:latin typeface="Arial" panose="020B0604020202020204" pitchFamily="34" charset="0"/>
                <a:cs typeface="Arial" panose="020B0604020202020204" pitchFamily="34" charset="0"/>
              </a:rPr>
              <a:t>ACY-73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7BA7C3B-40D2-78C9-997E-0A9A3EF015C8}"/>
              </a:ext>
            </a:extLst>
          </p:cNvPr>
          <p:cNvSpPr txBox="1"/>
          <p:nvPr/>
        </p:nvSpPr>
        <p:spPr>
          <a:xfrm rot="16200000">
            <a:off x="1722296" y="3384055"/>
            <a:ext cx="926023" cy="284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50" b="1" dirty="0">
                <a:latin typeface="Arial" panose="020B0604020202020204" pitchFamily="34" charset="0"/>
                <a:cs typeface="Arial" panose="020B0604020202020204" pitchFamily="34" charset="0"/>
              </a:rPr>
              <a:t>ACY-1215</a:t>
            </a:r>
          </a:p>
        </p:txBody>
      </p:sp>
      <p:graphicFrame>
        <p:nvGraphicFramePr>
          <p:cNvPr id="29" name="Chart 28">
            <a:extLst>
              <a:ext uri="{FF2B5EF4-FFF2-40B4-BE49-F238E27FC236}">
                <a16:creationId xmlns:a16="http://schemas.microsoft.com/office/drawing/2014/main" id="{A479F7CA-3230-9041-F6F7-136C06887E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8851002"/>
              </p:ext>
            </p:extLst>
          </p:nvPr>
        </p:nvGraphicFramePr>
        <p:xfrm>
          <a:off x="5966243" y="1246588"/>
          <a:ext cx="5073997" cy="36785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089CE3E1-2273-17E0-587F-EC502FA5E2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7147" y="1076279"/>
            <a:ext cx="2622893" cy="397382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04398" y="0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8D9895D-F82A-EC43-97F7-7EC07D77F178}"/>
              </a:ext>
            </a:extLst>
          </p:cNvPr>
          <p:cNvSpPr txBox="1"/>
          <p:nvPr/>
        </p:nvSpPr>
        <p:spPr>
          <a:xfrm rot="16200000">
            <a:off x="1282452" y="2916573"/>
            <a:ext cx="11655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 flipH="1">
            <a:off x="2010189" y="1206570"/>
            <a:ext cx="8529" cy="384353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 rot="16200000">
            <a:off x="4428611" y="2444634"/>
            <a:ext cx="307526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luorescent Green Area (µm</a:t>
            </a:r>
            <a:r>
              <a:rPr lang="en-US" sz="1600" b="1" baseline="30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A479F7CA-3230-9041-F6F7-136C06887E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044732"/>
              </p:ext>
            </p:extLst>
          </p:nvPr>
        </p:nvGraphicFramePr>
        <p:xfrm>
          <a:off x="6118643" y="1398988"/>
          <a:ext cx="5073997" cy="36785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A9B26090-C4AB-AE36-F33A-81EF497F9AF0}"/>
              </a:ext>
            </a:extLst>
          </p:cNvPr>
          <p:cNvSpPr txBox="1"/>
          <p:nvPr/>
        </p:nvSpPr>
        <p:spPr>
          <a:xfrm>
            <a:off x="6968577" y="1234215"/>
            <a:ext cx="163859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MM cells</a:t>
            </a:r>
          </a:p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MM cells + Tubastatin A</a:t>
            </a:r>
          </a:p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MM cells + ACY-1215</a:t>
            </a:r>
          </a:p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MM cells + ACY-73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8607167" y="1325156"/>
            <a:ext cx="235974" cy="0"/>
          </a:xfrm>
          <a:prstGeom prst="line">
            <a:avLst/>
          </a:prstGeom>
          <a:ln w="317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8612083" y="1479706"/>
            <a:ext cx="235974" cy="0"/>
          </a:xfrm>
          <a:prstGeom prst="line">
            <a:avLst/>
          </a:prstGeom>
          <a:ln w="31750">
            <a:solidFill>
              <a:srgbClr val="FFCC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8607167" y="1635230"/>
            <a:ext cx="235974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8612083" y="1792192"/>
            <a:ext cx="235974" cy="0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1568334" y="5352748"/>
            <a:ext cx="947190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17. 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HDAC6 inhibitors on the expansion of MM spheroids cultured alone or with T-cells. 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M patient CD138</a:t>
            </a:r>
            <a:r>
              <a:rPr lang="en-US" sz="1200" baseline="300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cells (50,000/ sample)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ere cultured in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50 μL of Matrigel (Corning) in 96-well plates according to the manufacturer’s protocol. Spheroids were allowed to form and maintained at 37 °C. Cells were then treated with HDAC6 inhibitors (1 uM) for 24 h followed by co-culture with T-cells (E:T 2;1) for another 24 h. Values represent the average of triplicate measurements.  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3442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150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12:08Z</dcterms:modified>
</cp:coreProperties>
</file>